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56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>
      <p:cViewPr varScale="1">
        <p:scale>
          <a:sx n="56" d="100"/>
          <a:sy n="56" d="100"/>
        </p:scale>
        <p:origin x="1336" y="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4/10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10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10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10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10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10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10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10/2022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10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10/2022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10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10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4/10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creativecommons.org/licenses/by/4.0/" TargetMode="Externa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hyperlink" Target="http://creativecommons.org/licenses/by/4.0/" TargetMode="Externa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Remodelling of uteroplacental (‘spiral’) arteries during pregnancy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59F054D-AB47-0E45-9F53-CB11F6DB3E35}"/>
              </a:ext>
            </a:extLst>
          </p:cNvPr>
          <p:cNvSpPr txBox="1"/>
          <p:nvPr/>
        </p:nvSpPr>
        <p:spPr>
          <a:xfrm>
            <a:off x="44478" y="5624450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Desoye</a:t>
            </a:r>
            <a:r>
              <a:rPr lang="en-GB" dirty="0"/>
              <a:t> et al (2022) Diabetologia DOI 10.1007/s00125-022-05820-4 </a:t>
            </a:r>
          </a:p>
          <a:p>
            <a:r>
              <a:rPr lang="en-GB" sz="1200" dirty="0"/>
              <a:t>© 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82EC21F-C677-D33B-0F65-C7F495D90E0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01617" y="836712"/>
            <a:ext cx="5606687" cy="49569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51520" y="272842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The effect of maternal </a:t>
            </a:r>
            <a:r>
              <a:rPr lang="en-US" sz="2000" b="1" dirty="0" err="1"/>
              <a:t>hyperglycaemia</a:t>
            </a:r>
            <a:r>
              <a:rPr lang="en-US" sz="2000" b="1" dirty="0"/>
              <a:t> on birthweight category depends on early placental size and function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D41054A1-0F1C-A04E-AAA4-9AD63610B41E}"/>
              </a:ext>
            </a:extLst>
          </p:cNvPr>
          <p:cNvSpPr txBox="1"/>
          <p:nvPr/>
        </p:nvSpPr>
        <p:spPr>
          <a:xfrm>
            <a:off x="44478" y="5624450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esoye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2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2-05820-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The Authors 2022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3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2985EE2-1C25-2230-93BC-08C8E1F97D7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02309" y="1196752"/>
            <a:ext cx="5261979" cy="4491515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95536" y="332656"/>
            <a:ext cx="820891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Effects on birthweight of different scenarios during pregnancy in women with type 1 diabetes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C1CFC375-E6B7-4648-8EB2-D12F2AEDAE66}"/>
              </a:ext>
            </a:extLst>
          </p:cNvPr>
          <p:cNvSpPr txBox="1"/>
          <p:nvPr/>
        </p:nvSpPr>
        <p:spPr>
          <a:xfrm>
            <a:off x="44478" y="5725705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esoye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2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2-05820-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The Authors 2022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3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0E2FB12-000B-A3E7-D0E0-DB5C525FB4C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82409" y="1090459"/>
            <a:ext cx="5381879" cy="47971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9</Words>
  <Application>Microsoft Office PowerPoint</Application>
  <PresentationFormat>On-screen Show (4:3)</PresentationFormat>
  <Paragraphs>13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1</cp:revision>
  <dcterms:created xsi:type="dcterms:W3CDTF">2016-06-15T12:53:43Z</dcterms:created>
  <dcterms:modified xsi:type="dcterms:W3CDTF">2022-10-24T10:39:39Z</dcterms:modified>
</cp:coreProperties>
</file>